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80" r:id="rId5"/>
    <p:sldId id="282" r:id="rId6"/>
    <p:sldId id="283" r:id="rId7"/>
    <p:sldId id="285" r:id="rId8"/>
    <p:sldId id="286" r:id="rId9"/>
    <p:sldId id="288" r:id="rId10"/>
    <p:sldId id="289" r:id="rId11"/>
    <p:sldId id="290" r:id="rId12"/>
    <p:sldId id="291" r:id="rId13"/>
    <p:sldId id="292" r:id="rId14"/>
    <p:sldId id="293" r:id="rId1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46ABAE6-D0D7-46A4-AF5D-72EBC6E8C14E}" v="263" dt="2021-06-07T15:26:55.83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608" autoAdjust="0"/>
    <p:restoredTop sz="94660"/>
  </p:normalViewPr>
  <p:slideViewPr>
    <p:cSldViewPr snapToGrid="0">
      <p:cViewPr varScale="1">
        <p:scale>
          <a:sx n="50" d="100"/>
          <a:sy n="50" d="100"/>
        </p:scale>
        <p:origin x="2458" y="6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21" Type="http://schemas.microsoft.com/office/2015/10/relationships/revisionInfo" Target="revisionInfo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712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5608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350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609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18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885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372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632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479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7968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797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9E638-8FEC-4DAC-BA5E-DF800F4F9834}" type="datetimeFigureOut">
              <a:rPr lang="en-GB" smtClean="0"/>
              <a:pPr/>
              <a:t>22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FDFB4-69C0-4763-BC88-21C1761C94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5914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2">
            <a:extLst>
              <a:ext uri="{FF2B5EF4-FFF2-40B4-BE49-F238E27FC236}">
                <a16:creationId xmlns:a16="http://schemas.microsoft.com/office/drawing/2014/main" xmlns="" id="{B67624B7-A42A-CD47-8911-97645A47D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53550" y="377622"/>
            <a:ext cx="4371086" cy="371357"/>
          </a:xfrm>
        </p:spPr>
        <p:txBody>
          <a:bodyPr>
            <a:norm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. Primary patency</a:t>
            </a: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xmlns="" id="{28664FE4-13DF-AC4D-B9BC-1A1B25B9AFD4}"/>
              </a:ext>
            </a:extLst>
          </p:cNvPr>
          <p:cNvSpPr txBox="1">
            <a:spLocks/>
          </p:cNvSpPr>
          <p:nvPr/>
        </p:nvSpPr>
        <p:spPr>
          <a:xfrm>
            <a:off x="653550" y="4353028"/>
            <a:ext cx="4371086" cy="3713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. Secondary patency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xmlns="" id="{E18066D3-B6AD-1D47-BEAF-84176A42B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5569" y="7502414"/>
            <a:ext cx="6368097" cy="1222012"/>
          </a:xfrm>
        </p:spPr>
        <p:txBody>
          <a:bodyPr>
            <a:norm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atency following venous stenting for non-thrombotic iliac vein lesions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Key: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* events reported per limb 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xmlns="" id="{877C7858-F04D-4E66-BF58-F67E93A162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200" y="858622"/>
            <a:ext cx="6193466" cy="3370478"/>
          </a:xfrm>
          <a:prstGeom prst="rect">
            <a:avLst/>
          </a:prstGeom>
        </p:spPr>
      </p:pic>
      <p:pic>
        <p:nvPicPr>
          <p:cNvPr id="12" name="Picture 11" descr="Chart&#10;&#10;Description automatically generated">
            <a:extLst>
              <a:ext uri="{FF2B5EF4-FFF2-40B4-BE49-F238E27FC236}">
                <a16:creationId xmlns:a16="http://schemas.microsoft.com/office/drawing/2014/main" xmlns="" id="{88F3FBB1-1D93-48FC-A6B9-E69BC5A9272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502" y="4848099"/>
            <a:ext cx="6317776" cy="2530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15873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="" xmlns:a16="http://schemas.microsoft.com/office/drawing/2014/main" id="{5E639678-92AF-4F7A-9C82-32729E788508}"/>
              </a:ext>
            </a:extLst>
          </p:cNvPr>
          <p:cNvGraphicFramePr>
            <a:graphicFrameLocks noGrp="1"/>
          </p:cNvGraphicFramePr>
          <p:nvPr/>
        </p:nvGraphicFramePr>
        <p:xfrm>
          <a:off x="621035" y="419420"/>
          <a:ext cx="5615929" cy="1177988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80000">
                  <a:extLst>
                    <a:ext uri="{9D8B030D-6E8A-4147-A177-3AD203B41FA5}">
                      <a16:colId xmlns="" xmlns:a16="http://schemas.microsoft.com/office/drawing/2014/main" val="1884283414"/>
                    </a:ext>
                  </a:extLst>
                </a:gridCol>
                <a:gridCol w="335545">
                  <a:extLst>
                    <a:ext uri="{9D8B030D-6E8A-4147-A177-3AD203B41FA5}">
                      <a16:colId xmlns="" xmlns:a16="http://schemas.microsoft.com/office/drawing/2014/main" val="682406734"/>
                    </a:ext>
                  </a:extLst>
                </a:gridCol>
                <a:gridCol w="314908">
                  <a:extLst>
                    <a:ext uri="{9D8B030D-6E8A-4147-A177-3AD203B41FA5}">
                      <a16:colId xmlns="" xmlns:a16="http://schemas.microsoft.com/office/drawing/2014/main" val="1459614979"/>
                    </a:ext>
                  </a:extLst>
                </a:gridCol>
                <a:gridCol w="633995">
                  <a:extLst>
                    <a:ext uri="{9D8B030D-6E8A-4147-A177-3AD203B41FA5}">
                      <a16:colId xmlns="" xmlns:a16="http://schemas.microsoft.com/office/drawing/2014/main" val="1718403901"/>
                    </a:ext>
                  </a:extLst>
                </a:gridCol>
                <a:gridCol w="1029600">
                  <a:extLst>
                    <a:ext uri="{9D8B030D-6E8A-4147-A177-3AD203B41FA5}">
                      <a16:colId xmlns="" xmlns:a16="http://schemas.microsoft.com/office/drawing/2014/main" val="498073857"/>
                    </a:ext>
                  </a:extLst>
                </a:gridCol>
                <a:gridCol w="270458">
                  <a:extLst>
                    <a:ext uri="{9D8B030D-6E8A-4147-A177-3AD203B41FA5}">
                      <a16:colId xmlns="" xmlns:a16="http://schemas.microsoft.com/office/drawing/2014/main" val="1427497974"/>
                    </a:ext>
                  </a:extLst>
                </a:gridCol>
                <a:gridCol w="1119823">
                  <a:extLst>
                    <a:ext uri="{9D8B030D-6E8A-4147-A177-3AD203B41FA5}">
                      <a16:colId xmlns="" xmlns:a16="http://schemas.microsoft.com/office/drawing/2014/main" val="1880922891"/>
                    </a:ext>
                  </a:extLst>
                </a:gridCol>
                <a:gridCol w="831600">
                  <a:extLst>
                    <a:ext uri="{9D8B030D-6E8A-4147-A177-3AD203B41FA5}">
                      <a16:colId xmlns="" xmlns:a16="http://schemas.microsoft.com/office/drawing/2014/main" val="192494591"/>
                    </a:ext>
                  </a:extLst>
                </a:gridCol>
              </a:tblGrid>
              <a:tr h="1008000"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ud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ate of public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hology typ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Treatment</a:t>
                      </a:r>
                    </a:p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erio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ent trade nam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ients</a:t>
                      </a: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Anticoagul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ur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extLst>
                  <a:ext uri="{0D108BD9-81ED-4DB2-BD59-A6C34878D82A}">
                    <a16:rowId xmlns="" xmlns:a16="http://schemas.microsoft.com/office/drawing/2014/main" val="1359762796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Falcoz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2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rotégé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07413978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Jia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-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6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59329113"/>
                  </a:ext>
                </a:extLst>
              </a:tr>
              <a:tr h="402776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Ye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0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Lifelong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34161463"/>
                  </a:ext>
                </a:extLst>
              </a:tr>
              <a:tr h="48591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Abdul-Haqq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3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7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214543393"/>
                  </a:ext>
                </a:extLst>
              </a:tr>
              <a:tr h="6521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ngelberger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1-2013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veno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XL 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XL superfle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Zilver vena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/LMWH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234531821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Jiang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8-201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MAR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/LMWH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949801183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Murphy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7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65596922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artovi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8-201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Lifelong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64825237"/>
                  </a:ext>
                </a:extLst>
              </a:tr>
              <a:tr h="402776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Ruihua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3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8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Lifelong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739787210"/>
                  </a:ext>
                </a:extLst>
              </a:tr>
              <a:tr h="106786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van Vuuren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3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9-201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obliqu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veno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XL 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superflex</a:t>
                      </a:r>
                      <a:endParaRPr lang="en-GB" sz="1000" dirty="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Veniti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vici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Venovo</a:t>
                      </a:r>
                      <a:endParaRPr lang="en-GB" sz="1000" dirty="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Zilver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vena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6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rfarin &amp; LMWH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781006389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Black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4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XL</a:t>
                      </a: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Vici venovo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8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637310416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Grøtta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6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9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altep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075527219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Liu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6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4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9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/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Rivaroxaban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543108426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Rizvi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6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3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1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011541314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Ye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6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2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1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775495592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Yu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6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9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MAR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4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6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841951230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vgerinos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7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7-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rotégé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7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7934171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156677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="" xmlns:a16="http://schemas.microsoft.com/office/drawing/2014/main" id="{6215CE88-D4B5-48EB-8D28-4B5CCD24A9FB}"/>
              </a:ext>
            </a:extLst>
          </p:cNvPr>
          <p:cNvGraphicFramePr>
            <a:graphicFrameLocks noGrp="1"/>
          </p:cNvGraphicFramePr>
          <p:nvPr/>
        </p:nvGraphicFramePr>
        <p:xfrm>
          <a:off x="620698" y="121920"/>
          <a:ext cx="5616591" cy="10888685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80000">
                  <a:extLst>
                    <a:ext uri="{9D8B030D-6E8A-4147-A177-3AD203B41FA5}">
                      <a16:colId xmlns="" xmlns:a16="http://schemas.microsoft.com/office/drawing/2014/main" val="656253609"/>
                    </a:ext>
                  </a:extLst>
                </a:gridCol>
                <a:gridCol w="335545">
                  <a:extLst>
                    <a:ext uri="{9D8B030D-6E8A-4147-A177-3AD203B41FA5}">
                      <a16:colId xmlns="" xmlns:a16="http://schemas.microsoft.com/office/drawing/2014/main" val="3387973445"/>
                    </a:ext>
                  </a:extLst>
                </a:gridCol>
                <a:gridCol w="314908">
                  <a:extLst>
                    <a:ext uri="{9D8B030D-6E8A-4147-A177-3AD203B41FA5}">
                      <a16:colId xmlns="" xmlns:a16="http://schemas.microsoft.com/office/drawing/2014/main" val="4105020437"/>
                    </a:ext>
                  </a:extLst>
                </a:gridCol>
                <a:gridCol w="633995">
                  <a:extLst>
                    <a:ext uri="{9D8B030D-6E8A-4147-A177-3AD203B41FA5}">
                      <a16:colId xmlns="" xmlns:a16="http://schemas.microsoft.com/office/drawing/2014/main" val="3938007046"/>
                    </a:ext>
                  </a:extLst>
                </a:gridCol>
                <a:gridCol w="1029600">
                  <a:extLst>
                    <a:ext uri="{9D8B030D-6E8A-4147-A177-3AD203B41FA5}">
                      <a16:colId xmlns="" xmlns:a16="http://schemas.microsoft.com/office/drawing/2014/main" val="1684728710"/>
                    </a:ext>
                  </a:extLst>
                </a:gridCol>
                <a:gridCol w="270458">
                  <a:extLst>
                    <a:ext uri="{9D8B030D-6E8A-4147-A177-3AD203B41FA5}">
                      <a16:colId xmlns="" xmlns:a16="http://schemas.microsoft.com/office/drawing/2014/main" val="907310037"/>
                    </a:ext>
                  </a:extLst>
                </a:gridCol>
                <a:gridCol w="1119600">
                  <a:extLst>
                    <a:ext uri="{9D8B030D-6E8A-4147-A177-3AD203B41FA5}">
                      <a16:colId xmlns="" xmlns:a16="http://schemas.microsoft.com/office/drawing/2014/main" val="321904101"/>
                    </a:ext>
                  </a:extLst>
                </a:gridCol>
                <a:gridCol w="832485">
                  <a:extLst>
                    <a:ext uri="{9D8B030D-6E8A-4147-A177-3AD203B41FA5}">
                      <a16:colId xmlns="" xmlns:a16="http://schemas.microsoft.com/office/drawing/2014/main" val="1502248044"/>
                    </a:ext>
                  </a:extLst>
                </a:gridCol>
              </a:tblGrid>
              <a:tr h="1008000"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ud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ate of public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hology typ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Treatment</a:t>
                      </a:r>
                    </a:p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erio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ent trade nam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ients</a:t>
                      </a: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Anticoagul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ur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extLst>
                  <a:ext uri="{0D108BD9-81ED-4DB2-BD59-A6C34878D82A}">
                    <a16:rowId xmlns="" xmlns:a16="http://schemas.microsoft.com/office/drawing/2014/main" val="2875806374"/>
                  </a:ext>
                </a:extLst>
              </a:tr>
              <a:tr h="1444129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Funatsu</a:t>
                      </a: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7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0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E-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Epic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Expres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almaz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MAR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/DOAC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14352169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Gagne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2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2007-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6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6 to 12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461124044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Ignatyev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9-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7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/DOAC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589142588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Menez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3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0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Zilver vena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9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/DOAC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3 to 6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078453506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Razavi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5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eniti Vici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17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57103645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Jayaraj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2014-201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55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684953571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Jiang et al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4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4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321849156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Lichtenberg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6-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7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Warfarin/DOAC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6 to 12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50126293"/>
                  </a:ext>
                </a:extLst>
              </a:tr>
              <a:tr h="111758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Moeri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8-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Blueflow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inus Repo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ici venou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15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91790736"/>
                  </a:ext>
                </a:extLst>
              </a:tr>
              <a:tr h="193395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ebastian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Abre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 </a:t>
                      </a: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superflex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inus obliqu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Vici </a:t>
                      </a: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Zilver</a:t>
                      </a: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vena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37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ea typeface="Arial" panose="020B0604020202020204" pitchFamily="34" charset="0"/>
                        </a:rPr>
                        <a:t>Unspecified</a:t>
                      </a:r>
                      <a:endParaRPr lang="en-GB" sz="11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3 to 12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2567725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70524DCE-F9FB-491D-9BFC-47B9C606773A}"/>
              </a:ext>
            </a:extLst>
          </p:cNvPr>
          <p:cNvSpPr txBox="1"/>
          <p:nvPr/>
        </p:nvSpPr>
        <p:spPr>
          <a:xfrm>
            <a:off x="2228984" y="10998815"/>
            <a:ext cx="2400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  <a:b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ost intervention anticoagulation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885982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xmlns="" id="{204F8761-8F2D-42FB-B225-9301107F44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00" y="1057157"/>
            <a:ext cx="6367654" cy="4547068"/>
          </a:xfrm>
          <a:prstGeom prst="rect">
            <a:avLst/>
          </a:prstGeom>
        </p:spPr>
      </p:pic>
      <p:sp>
        <p:nvSpPr>
          <p:cNvPr id="7" name="Text Placeholder 2">
            <a:extLst>
              <a:ext uri="{FF2B5EF4-FFF2-40B4-BE49-F238E27FC236}">
                <a16:creationId xmlns:a16="http://schemas.microsoft.com/office/drawing/2014/main" xmlns="" id="{B67624B7-A42A-CD47-8911-97645A47D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05560" y="685800"/>
            <a:ext cx="4371086" cy="371357"/>
          </a:xfrm>
        </p:spPr>
        <p:txBody>
          <a:bodyPr>
            <a:norm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. Primary patency</a:t>
            </a: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xmlns="" id="{28664FE4-13DF-AC4D-B9BC-1A1B25B9AFD4}"/>
              </a:ext>
            </a:extLst>
          </p:cNvPr>
          <p:cNvSpPr txBox="1">
            <a:spLocks/>
          </p:cNvSpPr>
          <p:nvPr/>
        </p:nvSpPr>
        <p:spPr>
          <a:xfrm>
            <a:off x="805560" y="5656690"/>
            <a:ext cx="4371086" cy="3713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. Secondary patency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xmlns="" id="{E18066D3-B6AD-1D47-BEAF-84176A42B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8300" y="10098094"/>
            <a:ext cx="6367654" cy="1509706"/>
          </a:xfrm>
        </p:spPr>
        <p:txBody>
          <a:bodyPr>
            <a:normAutofit fontScale="90000"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b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atency following venous stenting as part of treatment for acute DVT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Key:</a:t>
            </a:r>
            <a:b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* events reported per limb</a:t>
            </a:r>
            <a:b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open thrombectomy carried out before stent</a:t>
            </a:r>
            <a:b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ay include some patient duplicates</a:t>
            </a:r>
            <a:b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xmlns="" id="{F686FAA1-011D-4638-9F56-14A17C8D0DC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00" y="6012983"/>
            <a:ext cx="6367654" cy="3676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4760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2">
            <a:extLst>
              <a:ext uri="{FF2B5EF4-FFF2-40B4-BE49-F238E27FC236}">
                <a16:creationId xmlns:a16="http://schemas.microsoft.com/office/drawing/2014/main" xmlns="" id="{B67624B7-A42A-CD47-8911-97645A47D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05560" y="280299"/>
            <a:ext cx="4371086" cy="371357"/>
          </a:xfrm>
        </p:spPr>
        <p:txBody>
          <a:bodyPr>
            <a:norm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. Primary patency</a:t>
            </a:r>
          </a:p>
        </p:txBody>
      </p:sp>
      <p:sp>
        <p:nvSpPr>
          <p:cNvPr id="18" name="Text Placeholder 2">
            <a:extLst>
              <a:ext uri="{FF2B5EF4-FFF2-40B4-BE49-F238E27FC236}">
                <a16:creationId xmlns:a16="http://schemas.microsoft.com/office/drawing/2014/main" xmlns="" id="{C82EE1C8-A4F9-E740-9BD5-BF2320636AA2}"/>
              </a:ext>
            </a:extLst>
          </p:cNvPr>
          <p:cNvSpPr txBox="1">
            <a:spLocks/>
          </p:cNvSpPr>
          <p:nvPr/>
        </p:nvSpPr>
        <p:spPr>
          <a:xfrm>
            <a:off x="805560" y="2880924"/>
            <a:ext cx="4371086" cy="3713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. Secondary patency</a:t>
            </a:r>
          </a:p>
        </p:txBody>
      </p:sp>
      <p:sp>
        <p:nvSpPr>
          <p:cNvPr id="20" name="Title 1">
            <a:extLst>
              <a:ext uri="{FF2B5EF4-FFF2-40B4-BE49-F238E27FC236}">
                <a16:creationId xmlns:a16="http://schemas.microsoft.com/office/drawing/2014/main" xmlns="" id="{B2F43A9C-880B-D443-8EDD-0F4A7F757C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7763" y="5855766"/>
            <a:ext cx="5373874" cy="1638224"/>
          </a:xfrm>
        </p:spPr>
        <p:txBody>
          <a:bodyPr>
            <a:norm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atency following venous stenting placed above the inguinal ligament for treatment of post-thrombotic syndrome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Key: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* events reported per limb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hronic total occlusions only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xmlns="" id="{2D70F645-96A2-4863-8C45-B076E7E5EE0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550" y="3329320"/>
            <a:ext cx="6438900" cy="2187803"/>
          </a:xfrm>
          <a:prstGeom prst="rect">
            <a:avLst/>
          </a:prstGeom>
        </p:spPr>
      </p:pic>
      <p:pic>
        <p:nvPicPr>
          <p:cNvPr id="9" name="Picture 8" descr="Chart, box and whisker chart&#10;&#10;Description automatically generated">
            <a:extLst>
              <a:ext uri="{FF2B5EF4-FFF2-40B4-BE49-F238E27FC236}">
                <a16:creationId xmlns:a16="http://schemas.microsoft.com/office/drawing/2014/main" xmlns="" id="{A99916DE-10A5-4F56-9FB4-6721FFAD6F5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550" y="651656"/>
            <a:ext cx="6438900" cy="2152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38398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2">
            <a:extLst>
              <a:ext uri="{FF2B5EF4-FFF2-40B4-BE49-F238E27FC236}">
                <a16:creationId xmlns:a16="http://schemas.microsoft.com/office/drawing/2014/main" xmlns="" id="{B67624B7-A42A-CD47-8911-97645A47D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35887" y="280298"/>
            <a:ext cx="4371086" cy="371357"/>
          </a:xfrm>
        </p:spPr>
        <p:txBody>
          <a:bodyPr>
            <a:norm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. Primary patency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C0AE48A-7C75-4D1C-9A6E-5DBF3103448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046" y="651655"/>
            <a:ext cx="6065908" cy="5320236"/>
          </a:xfrm>
          <a:prstGeom prst="rect">
            <a:avLst/>
          </a:prstGeom>
        </p:spPr>
      </p:pic>
      <p:sp>
        <p:nvSpPr>
          <p:cNvPr id="6" name="Text Placeholder 2">
            <a:extLst>
              <a:ext uri="{FF2B5EF4-FFF2-40B4-BE49-F238E27FC236}">
                <a16:creationId xmlns:a16="http://schemas.microsoft.com/office/drawing/2014/main" xmlns="" id="{212F5FEA-F933-5D42-B05A-ACC102E042DF}"/>
              </a:ext>
            </a:extLst>
          </p:cNvPr>
          <p:cNvSpPr txBox="1">
            <a:spLocks/>
          </p:cNvSpPr>
          <p:nvPr/>
        </p:nvSpPr>
        <p:spPr>
          <a:xfrm>
            <a:off x="735887" y="6096000"/>
            <a:ext cx="4371086" cy="3713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. Secondary patency</a:t>
            </a:r>
          </a:p>
        </p:txBody>
      </p:sp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xmlns="" id="{E844424C-B013-2344-A2E7-243DEC6B391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046" y="6467357"/>
            <a:ext cx="6127924" cy="4959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29499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xmlns="" id="{0DE72719-9520-F84D-B73D-046EE84B1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2135" y="622570"/>
            <a:ext cx="5093730" cy="2971529"/>
          </a:xfrm>
        </p:spPr>
        <p:txBody>
          <a:bodyPr>
            <a:norm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atency following venous stenting across the inguinal ligament for treatment of post-thrombotic syndrome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Key: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* events reported per limb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ay include some patient duplicates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hronic total occlusions only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clusion of 3 patients with dedicated venous stents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ε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femoral vein intervention with angioplasty +/- stent carried out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nly braided nitinol stents included from this manuscript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# inclusion of patients with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endophlebectomy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+/- fistula</a:t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6682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="" xmlns:a16="http://schemas.microsoft.com/office/drawing/2014/main" id="{846FC3AE-AAD7-4016-81DC-67A7F8B3378D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49160" y="267132"/>
          <a:ext cx="6527455" cy="1228560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80000">
                  <a:extLst>
                    <a:ext uri="{9D8B030D-6E8A-4147-A177-3AD203B41FA5}">
                      <a16:colId xmlns="" xmlns:a16="http://schemas.microsoft.com/office/drawing/2014/main" val="746216930"/>
                    </a:ext>
                  </a:extLst>
                </a:gridCol>
                <a:gridCol w="360000">
                  <a:extLst>
                    <a:ext uri="{9D8B030D-6E8A-4147-A177-3AD203B41FA5}">
                      <a16:colId xmlns="" xmlns:a16="http://schemas.microsoft.com/office/drawing/2014/main" val="3984610059"/>
                    </a:ext>
                  </a:extLst>
                </a:gridCol>
                <a:gridCol w="360000">
                  <a:extLst>
                    <a:ext uri="{9D8B030D-6E8A-4147-A177-3AD203B41FA5}">
                      <a16:colId xmlns="" xmlns:a16="http://schemas.microsoft.com/office/drawing/2014/main" val="627787940"/>
                    </a:ext>
                  </a:extLst>
                </a:gridCol>
                <a:gridCol w="624787">
                  <a:extLst>
                    <a:ext uri="{9D8B030D-6E8A-4147-A177-3AD203B41FA5}">
                      <a16:colId xmlns="" xmlns:a16="http://schemas.microsoft.com/office/drawing/2014/main" val="1244191035"/>
                    </a:ext>
                  </a:extLst>
                </a:gridCol>
                <a:gridCol w="964512">
                  <a:extLst>
                    <a:ext uri="{9D8B030D-6E8A-4147-A177-3AD203B41FA5}">
                      <a16:colId xmlns="" xmlns:a16="http://schemas.microsoft.com/office/drawing/2014/main" val="3443388690"/>
                    </a:ext>
                  </a:extLst>
                </a:gridCol>
                <a:gridCol w="258156">
                  <a:extLst>
                    <a:ext uri="{9D8B030D-6E8A-4147-A177-3AD203B41FA5}">
                      <a16:colId xmlns="" xmlns:a16="http://schemas.microsoft.com/office/drawing/2014/main" val="1306257271"/>
                    </a:ext>
                  </a:extLst>
                </a:gridCol>
                <a:gridCol w="2880000">
                  <a:extLst>
                    <a:ext uri="{9D8B030D-6E8A-4147-A177-3AD203B41FA5}">
                      <a16:colId xmlns="" xmlns:a16="http://schemas.microsoft.com/office/drawing/2014/main" val="2610667834"/>
                    </a:ext>
                  </a:extLst>
                </a:gridCol>
              </a:tblGrid>
              <a:tr h="1008000"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ud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ate of public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hology typ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Treatment</a:t>
                      </a:r>
                    </a:p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erio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ent trade nam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ients</a:t>
                      </a: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Adverse even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extLst>
                  <a:ext uri="{0D108BD9-81ED-4DB2-BD59-A6C34878D82A}">
                    <a16:rowId xmlns="" xmlns:a16="http://schemas.microsoft.com/office/drawing/2014/main" val="75411342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Kwak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 spinal epidural haematoma and 1 stent migr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41739862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Husman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 peripheral sensory nerve les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57499871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Neglén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2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7-200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87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 retroperitoneal bleed, 1 femoral artery injury requiring open repair, 3 femoral artery pseudoaneurysms and 1 arteriovenous fistula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079324760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Raju &amp; Neglén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2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9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5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~40 cases of back pa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6359276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Hölper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6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Palmaz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GB" sz="1000" b="0" i="0" u="none" strike="noStrike" noProof="0" dirty="0">
                          <a:effectLst/>
                          <a:latin typeface="+mn-lt"/>
                        </a:rPr>
                        <a:t>1 stent dislodged during deployment of a second stent</a:t>
                      </a:r>
                      <a:endParaRPr lang="en-US" dirty="0">
                        <a:latin typeface="+mn-lt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98931329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Jeo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9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1 stent compression (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Zilver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stent)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033380603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Rosales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48416618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hlgre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3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51511252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Meng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NIVL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7-200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7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66012657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Hager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6-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rotégé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7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1 major ble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757831805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Meng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8-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err="1">
                          <a:effectLst/>
                          <a:latin typeface="+mn-lt"/>
                        </a:rPr>
                        <a:t>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4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610394256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Alerany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9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1 arterial injur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90633003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Liu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8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4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2 stent migrations, 5 minor bleeds and 41 cases of back pa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85100312"/>
                  </a:ext>
                </a:extLst>
              </a:tr>
              <a:tr h="44574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Matsuda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err="1">
                          <a:effectLst/>
                          <a:latin typeface="+mn-lt"/>
                        </a:rPr>
                        <a:t>Luminexx</a:t>
                      </a:r>
                      <a:endParaRPr lang="en-GB" sz="100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083255935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rk et al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-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5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2 stent migrations, 1 minor bleed and one arterial injur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31583203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ang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err="1">
                          <a:effectLst/>
                          <a:latin typeface="+mn-lt"/>
                        </a:rPr>
                        <a:t>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5 minor bleed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656332976"/>
                  </a:ext>
                </a:extLst>
              </a:tr>
              <a:tr h="3694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Ye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7-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Luminexx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57 cases of back pain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140831136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Zhu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Luminexx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5 cases of back pa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2189163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Fatima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-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rotégé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1 minor ble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91158144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rk &amp; So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1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32298080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rinivas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1-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957107476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Yi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7-201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Everflex</a:t>
                      </a:r>
                      <a:endParaRPr lang="en-GB" sz="1000" dirty="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v3 endovascular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2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59 cases of back pain and 32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606094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87859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="" xmlns:a16="http://schemas.microsoft.com/office/drawing/2014/main" id="{5E639678-92AF-4F7A-9C82-32729E78850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9566" y="396240"/>
          <a:ext cx="6566770" cy="1148992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80000">
                  <a:extLst>
                    <a:ext uri="{9D8B030D-6E8A-4147-A177-3AD203B41FA5}">
                      <a16:colId xmlns="" xmlns:a16="http://schemas.microsoft.com/office/drawing/2014/main" val="1884283414"/>
                    </a:ext>
                  </a:extLst>
                </a:gridCol>
                <a:gridCol w="360000">
                  <a:extLst>
                    <a:ext uri="{9D8B030D-6E8A-4147-A177-3AD203B41FA5}">
                      <a16:colId xmlns="" xmlns:a16="http://schemas.microsoft.com/office/drawing/2014/main" val="682406734"/>
                    </a:ext>
                  </a:extLst>
                </a:gridCol>
                <a:gridCol w="360000">
                  <a:extLst>
                    <a:ext uri="{9D8B030D-6E8A-4147-A177-3AD203B41FA5}">
                      <a16:colId xmlns="" xmlns:a16="http://schemas.microsoft.com/office/drawing/2014/main" val="1459614979"/>
                    </a:ext>
                  </a:extLst>
                </a:gridCol>
                <a:gridCol w="626400">
                  <a:extLst>
                    <a:ext uri="{9D8B030D-6E8A-4147-A177-3AD203B41FA5}">
                      <a16:colId xmlns="" xmlns:a16="http://schemas.microsoft.com/office/drawing/2014/main" val="1718403901"/>
                    </a:ext>
                  </a:extLst>
                </a:gridCol>
                <a:gridCol w="989912">
                  <a:extLst>
                    <a:ext uri="{9D8B030D-6E8A-4147-A177-3AD203B41FA5}">
                      <a16:colId xmlns="" xmlns:a16="http://schemas.microsoft.com/office/drawing/2014/main" val="498073857"/>
                    </a:ext>
                  </a:extLst>
                </a:gridCol>
                <a:gridCol w="270458">
                  <a:extLst>
                    <a:ext uri="{9D8B030D-6E8A-4147-A177-3AD203B41FA5}">
                      <a16:colId xmlns="" xmlns:a16="http://schemas.microsoft.com/office/drawing/2014/main" val="1427497974"/>
                    </a:ext>
                  </a:extLst>
                </a:gridCol>
                <a:gridCol w="2880000">
                  <a:extLst>
                    <a:ext uri="{9D8B030D-6E8A-4147-A177-3AD203B41FA5}">
                      <a16:colId xmlns="" xmlns:a16="http://schemas.microsoft.com/office/drawing/2014/main" val="1071802400"/>
                    </a:ext>
                  </a:extLst>
                </a:gridCol>
              </a:tblGrid>
              <a:tr h="1008000"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ud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ate of public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hology typ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Treatment</a:t>
                      </a:r>
                    </a:p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erio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ent trade nam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ients</a:t>
                      </a: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Adverse even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extLst>
                  <a:ext uri="{0D108BD9-81ED-4DB2-BD59-A6C34878D82A}">
                    <a16:rowId xmlns="" xmlns:a16="http://schemas.microsoft.com/office/drawing/2014/main" val="1359762796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Falcoz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2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rotégé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07413978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Jia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-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6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59329113"/>
                  </a:ext>
                </a:extLst>
              </a:tr>
              <a:tr h="402776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Ye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0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15 cases of back pain and 10 minor bleeds</a:t>
                      </a:r>
                      <a:r>
                        <a:rPr lang="en-GB" sz="11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34161463"/>
                  </a:ext>
                </a:extLst>
              </a:tr>
              <a:tr h="48591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Abdul-Haqq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3-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7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214543393"/>
                  </a:ext>
                </a:extLst>
              </a:tr>
              <a:tr h="6521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ngelberger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1-2013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veno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XL 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XL superfle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Zilver vena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234531821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Jiang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5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8-201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MAR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3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949801183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Murphy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7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2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65596922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artovi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8-201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64825237"/>
                  </a:ext>
                </a:extLst>
              </a:tr>
              <a:tr h="402776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Ruihua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3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81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46 cases of back pain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739787210"/>
                  </a:ext>
                </a:extLst>
              </a:tr>
              <a:tr h="106786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van Vuuren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3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9-201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obliqu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veno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inus XL 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superflex</a:t>
                      </a:r>
                      <a:endParaRPr lang="en-GB" sz="1000" dirty="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Veniti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vici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Venovo</a:t>
                      </a:r>
                      <a:endParaRPr lang="en-GB" sz="1000" dirty="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Zilver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vena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6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34 cases of stent compression, 32 minor bleeds, 12 major bleeds, 2 arterial injuries and 1 stent fracture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781006389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Black et al.</a:t>
                      </a:r>
                      <a:r>
                        <a:rPr lang="en-GB" sz="1000" baseline="30000">
                          <a:effectLst/>
                          <a:latin typeface="+mn-lt"/>
                        </a:rPr>
                        <a:t>6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4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Sinus XL</a:t>
                      </a: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Vici venovo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8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1 Spinal bleed, 5 stent compressions, 3 stent fractures and 1 stent 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maldeployed</a:t>
                      </a:r>
                      <a:r>
                        <a:rPr lang="en-GB" sz="11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637310416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Grøtta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6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9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3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075527219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Liu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6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4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9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1 minor bleed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543108426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Rizvi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6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3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1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011541314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Ye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6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2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E-Luminexx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1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GB" sz="11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775495592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Yu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6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9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MAR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4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2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841951230"/>
                  </a:ext>
                </a:extLst>
              </a:tr>
              <a:tr h="31964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vgerinos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7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7-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rotégé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7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5 minor bleeds and 2 maj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6935918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625240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="" xmlns:a16="http://schemas.microsoft.com/office/drawing/2014/main" id="{6215CE88-D4B5-48EB-8D28-4B5CCD24A9F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27213" y="256233"/>
          <a:ext cx="6403573" cy="10888685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80000">
                  <a:extLst>
                    <a:ext uri="{9D8B030D-6E8A-4147-A177-3AD203B41FA5}">
                      <a16:colId xmlns="" xmlns:a16="http://schemas.microsoft.com/office/drawing/2014/main" val="656253609"/>
                    </a:ext>
                  </a:extLst>
                </a:gridCol>
                <a:gridCol w="360000">
                  <a:extLst>
                    <a:ext uri="{9D8B030D-6E8A-4147-A177-3AD203B41FA5}">
                      <a16:colId xmlns="" xmlns:a16="http://schemas.microsoft.com/office/drawing/2014/main" val="3387973445"/>
                    </a:ext>
                  </a:extLst>
                </a:gridCol>
                <a:gridCol w="360000">
                  <a:extLst>
                    <a:ext uri="{9D8B030D-6E8A-4147-A177-3AD203B41FA5}">
                      <a16:colId xmlns="" xmlns:a16="http://schemas.microsoft.com/office/drawing/2014/main" val="4105020437"/>
                    </a:ext>
                  </a:extLst>
                </a:gridCol>
                <a:gridCol w="633995">
                  <a:extLst>
                    <a:ext uri="{9D8B030D-6E8A-4147-A177-3AD203B41FA5}">
                      <a16:colId xmlns="" xmlns:a16="http://schemas.microsoft.com/office/drawing/2014/main" val="3938007046"/>
                    </a:ext>
                  </a:extLst>
                </a:gridCol>
                <a:gridCol w="999120">
                  <a:extLst>
                    <a:ext uri="{9D8B030D-6E8A-4147-A177-3AD203B41FA5}">
                      <a16:colId xmlns="" xmlns:a16="http://schemas.microsoft.com/office/drawing/2014/main" val="1684728710"/>
                    </a:ext>
                  </a:extLst>
                </a:gridCol>
                <a:gridCol w="270458">
                  <a:extLst>
                    <a:ext uri="{9D8B030D-6E8A-4147-A177-3AD203B41FA5}">
                      <a16:colId xmlns="" xmlns:a16="http://schemas.microsoft.com/office/drawing/2014/main" val="907310037"/>
                    </a:ext>
                  </a:extLst>
                </a:gridCol>
                <a:gridCol w="2700000">
                  <a:extLst>
                    <a:ext uri="{9D8B030D-6E8A-4147-A177-3AD203B41FA5}">
                      <a16:colId xmlns="" xmlns:a16="http://schemas.microsoft.com/office/drawing/2014/main" val="214274155"/>
                    </a:ext>
                  </a:extLst>
                </a:gridCol>
              </a:tblGrid>
              <a:tr h="1008000"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ud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ate of public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hology typ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Treatment</a:t>
                      </a:r>
                    </a:p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erio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ent trade nam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ients</a:t>
                      </a: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Adverse even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extLst>
                  <a:ext uri="{0D108BD9-81ED-4DB2-BD59-A6C34878D82A}">
                    <a16:rowId xmlns="" xmlns:a16="http://schemas.microsoft.com/office/drawing/2014/main" val="2875806374"/>
                  </a:ext>
                </a:extLst>
              </a:tr>
              <a:tr h="1444129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Funatsu</a:t>
                      </a: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7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0-201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E-</a:t>
                      </a: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Luminexx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Epic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Expres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Palmaz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6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14352169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Gagne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2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2007-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6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461124044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Ignatyev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9-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7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589142588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Menez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3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0-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Zilver vena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9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078453506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Razavi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4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5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eniti Vici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17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10 stent fracture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57103645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Jayaraj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2014-201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55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5 major bleeds and 5 arterial injurie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684953571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Jiang et al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4-201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MART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46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3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321849156"/>
                  </a:ext>
                </a:extLst>
              </a:tr>
              <a:tr h="62775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Lichtenberg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16-2017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7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4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50126293"/>
                  </a:ext>
                </a:extLst>
              </a:tr>
              <a:tr h="111758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Moeri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8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08-201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Blueflow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inus Repo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Vici venous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15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2 maj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91790736"/>
                  </a:ext>
                </a:extLst>
              </a:tr>
              <a:tr h="193395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Sebastian et al.</a:t>
                      </a:r>
                      <a:r>
                        <a:rPr lang="en-GB" sz="1000" baseline="30000">
                          <a:effectLst/>
                          <a:latin typeface="+mn-lt"/>
                          <a:cs typeface="Arial" panose="020B0604020202020204" pitchFamily="34" charset="0"/>
                        </a:rPr>
                        <a:t>79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2020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V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Abre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inus XL </a:t>
                      </a: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superflex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inus obliquus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Vici </a:t>
                      </a: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venovo</a:t>
                      </a:r>
                      <a:endParaRPr lang="en-GB" sz="100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Zilver</a:t>
                      </a: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vena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37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310" marR="23310" marT="0" marB="0"/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4 pulmonary embolisms and 9 minor bleeds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  <a:p>
                      <a:pPr>
                        <a:lnSpc>
                          <a:spcPct val="115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GB" sz="1100" dirty="0">
                          <a:effectLst/>
                          <a:latin typeface="+mn-lt"/>
                          <a:ea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2567725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70524DCE-F9FB-491D-9BFC-47B9C606773A}"/>
              </a:ext>
            </a:extLst>
          </p:cNvPr>
          <p:cNvSpPr txBox="1"/>
          <p:nvPr/>
        </p:nvSpPr>
        <p:spPr>
          <a:xfrm>
            <a:off x="1588591" y="11138822"/>
            <a:ext cx="36808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b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ost intervention complications and adverse event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9371634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="" xmlns:a16="http://schemas.microsoft.com/office/drawing/2014/main" id="{846FC3AE-AAD7-4016-81DC-67A7F8B3378D}"/>
              </a:ext>
            </a:extLst>
          </p:cNvPr>
          <p:cNvGraphicFramePr>
            <a:graphicFrameLocks noGrp="1"/>
          </p:cNvGraphicFramePr>
          <p:nvPr/>
        </p:nvGraphicFramePr>
        <p:xfrm>
          <a:off x="665047" y="130278"/>
          <a:ext cx="5527905" cy="1259040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80000">
                  <a:extLst>
                    <a:ext uri="{9D8B030D-6E8A-4147-A177-3AD203B41FA5}">
                      <a16:colId xmlns="" xmlns:a16="http://schemas.microsoft.com/office/drawing/2014/main" val="746216930"/>
                    </a:ext>
                  </a:extLst>
                </a:gridCol>
                <a:gridCol w="334800">
                  <a:extLst>
                    <a:ext uri="{9D8B030D-6E8A-4147-A177-3AD203B41FA5}">
                      <a16:colId xmlns="" xmlns:a16="http://schemas.microsoft.com/office/drawing/2014/main" val="3984610059"/>
                    </a:ext>
                  </a:extLst>
                </a:gridCol>
                <a:gridCol w="302606">
                  <a:extLst>
                    <a:ext uri="{9D8B030D-6E8A-4147-A177-3AD203B41FA5}">
                      <a16:colId xmlns="" xmlns:a16="http://schemas.microsoft.com/office/drawing/2014/main" val="627787940"/>
                    </a:ext>
                  </a:extLst>
                </a:gridCol>
                <a:gridCol w="624787">
                  <a:extLst>
                    <a:ext uri="{9D8B030D-6E8A-4147-A177-3AD203B41FA5}">
                      <a16:colId xmlns="" xmlns:a16="http://schemas.microsoft.com/office/drawing/2014/main" val="1244191035"/>
                    </a:ext>
                  </a:extLst>
                </a:gridCol>
                <a:gridCol w="964512">
                  <a:extLst>
                    <a:ext uri="{9D8B030D-6E8A-4147-A177-3AD203B41FA5}">
                      <a16:colId xmlns="" xmlns:a16="http://schemas.microsoft.com/office/drawing/2014/main" val="3443388690"/>
                    </a:ext>
                  </a:extLst>
                </a:gridCol>
                <a:gridCol w="270000">
                  <a:extLst>
                    <a:ext uri="{9D8B030D-6E8A-4147-A177-3AD203B41FA5}">
                      <a16:colId xmlns="" xmlns:a16="http://schemas.microsoft.com/office/drawing/2014/main" val="1306257271"/>
                    </a:ext>
                  </a:extLst>
                </a:gridCol>
                <a:gridCol w="1119600">
                  <a:extLst>
                    <a:ext uri="{9D8B030D-6E8A-4147-A177-3AD203B41FA5}">
                      <a16:colId xmlns="" xmlns:a16="http://schemas.microsoft.com/office/drawing/2014/main" val="3965733727"/>
                    </a:ext>
                  </a:extLst>
                </a:gridCol>
                <a:gridCol w="831600">
                  <a:extLst>
                    <a:ext uri="{9D8B030D-6E8A-4147-A177-3AD203B41FA5}">
                      <a16:colId xmlns="" xmlns:a16="http://schemas.microsoft.com/office/drawing/2014/main" val="2083281372"/>
                    </a:ext>
                  </a:extLst>
                </a:gridCol>
              </a:tblGrid>
              <a:tr h="1008000"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udy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ate of public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hology typ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Treatment</a:t>
                      </a:r>
                    </a:p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erio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tent trade name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tients</a:t>
                      </a: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Anticoagul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uratio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 vert="vert270"/>
                </a:tc>
                <a:extLst>
                  <a:ext uri="{0D108BD9-81ED-4DB2-BD59-A6C34878D82A}">
                    <a16:rowId xmlns="" xmlns:a16="http://schemas.microsoft.com/office/drawing/2014/main" val="75411342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Kwak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41739862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Husman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57499871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Neglén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2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7-200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87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079324760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Raju &amp; Neglén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2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9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5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Lifelong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6359276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Hölper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6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Palmaz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 to 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98931329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Jeo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9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</a:p>
                    <a:p>
                      <a:pPr lvl="0" algn="just">
                        <a:lnSpc>
                          <a:spcPct val="200000"/>
                        </a:lnSpc>
                        <a:buNone/>
                      </a:pPr>
                      <a:r>
                        <a:rPr lang="en-GB" sz="1000" b="0" i="0" u="none" strike="noStrike" noProof="0">
                          <a:effectLst/>
                          <a:latin typeface="+mn-lt"/>
                        </a:rPr>
                        <a:t>Zilver (n=1)</a:t>
                      </a:r>
                      <a:endParaRPr lang="en-GB">
                        <a:latin typeface="+mn-lt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033380603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Rosales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48416618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hlgre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3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3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51511252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Meng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NIVL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997-200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7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660126572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Hager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6-20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rotégé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7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757831805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Meng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8-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err="1">
                          <a:effectLst/>
                          <a:latin typeface="+mn-lt"/>
                        </a:rPr>
                        <a:t>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4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610394256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Alerany</a:t>
                      </a:r>
                      <a:r>
                        <a:rPr lang="en-GB" sz="1000" dirty="0">
                          <a:effectLst/>
                          <a:latin typeface="+mn-lt"/>
                        </a:rPr>
                        <a:t>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9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Unspecified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90633003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Liu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NIVL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8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 err="1">
                          <a:effectLst/>
                          <a:latin typeface="+mn-lt"/>
                        </a:rPr>
                        <a:t>Wallstent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4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85100312"/>
                  </a:ext>
                </a:extLst>
              </a:tr>
              <a:tr h="44574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Matsuda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0-200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err="1">
                          <a:effectLst/>
                          <a:latin typeface="+mn-lt"/>
                        </a:rPr>
                        <a:t>Luminexx</a:t>
                      </a:r>
                      <a:endParaRPr lang="en-GB" sz="1000">
                        <a:effectLst/>
                        <a:latin typeface="+mn-lt"/>
                      </a:endParaRP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+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083255935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rk et al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-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5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31583203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ang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err="1">
                          <a:effectLst/>
                          <a:latin typeface="+mn-lt"/>
                        </a:rPr>
                        <a:t>Luminex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656332976"/>
                  </a:ext>
                </a:extLst>
              </a:tr>
              <a:tr h="3694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Ye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7-201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Luminexx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1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140831136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Zhu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49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0-20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E-</a:t>
                      </a:r>
                      <a:r>
                        <a:rPr lang="en-GB" sz="1000" dirty="0" err="1">
                          <a:effectLst/>
                          <a:latin typeface="+mn-lt"/>
                        </a:rPr>
                        <a:t>Luminexx</a:t>
                      </a:r>
                      <a:endParaRPr lang="en-GB" sz="1000" dirty="0" err="1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2189163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Fatima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0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5-2014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rotégé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7159" marR="17159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/DOAC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 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 to 1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91158144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ark &amp; So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1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01-200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37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2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322980807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rinivas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2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5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DV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2011-201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err="1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SMART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8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12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957107476"/>
                  </a:ext>
                </a:extLst>
              </a:tr>
              <a:tr h="29322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Yin et al.</a:t>
                      </a:r>
                      <a:r>
                        <a:rPr lang="en-GB" sz="1000" baseline="30000" dirty="0">
                          <a:effectLst/>
                          <a:latin typeface="+mn-lt"/>
                        </a:rPr>
                        <a:t>53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15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PTS</a:t>
                      </a:r>
                      <a:endParaRPr lang="en-GB" sz="10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2007-201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Wallstent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verflex</a:t>
                      </a:r>
                    </a:p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ev3 endovascular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>
                          <a:effectLst/>
                          <a:latin typeface="+mn-lt"/>
                        </a:rPr>
                        <a:t>122</a:t>
                      </a:r>
                      <a:endParaRPr lang="en-GB" sz="100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18706" marR="18706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Warfarin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</a:pPr>
                      <a:r>
                        <a:rPr lang="en-GB" sz="1000" dirty="0">
                          <a:effectLst/>
                          <a:latin typeface="+mn-lt"/>
                        </a:rPr>
                        <a:t>6</a:t>
                      </a:r>
                      <a:endParaRPr lang="en-GB" sz="1100" dirty="0">
                        <a:effectLst/>
                        <a:latin typeface="+mn-lt"/>
                        <a:ea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0609012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2568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F90F2ECA569EC488FE1B6EF59247D8A" ma:contentTypeVersion="13" ma:contentTypeDescription="Create a new document." ma:contentTypeScope="" ma:versionID="a659c763f6b188c4fe8839d5be69da5d">
  <xsd:schema xmlns:xsd="http://www.w3.org/2001/XMLSchema" xmlns:xs="http://www.w3.org/2001/XMLSchema" xmlns:p="http://schemas.microsoft.com/office/2006/metadata/properties" xmlns:ns3="7d1f0932-4085-4466-8da9-dc765d33f258" xmlns:ns4="80545e34-2c25-43b6-826b-2da9a1a25bb5" targetNamespace="http://schemas.microsoft.com/office/2006/metadata/properties" ma:root="true" ma:fieldsID="8eb537bb5089a767ac6b17cbae764c1f" ns3:_="" ns4:_="">
    <xsd:import namespace="7d1f0932-4085-4466-8da9-dc765d33f258"/>
    <xsd:import namespace="80545e34-2c25-43b6-826b-2da9a1a25bb5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DateTaken" minOccurs="0"/>
                <xsd:element ref="ns4:MediaServiceLocation" minOccurs="0"/>
                <xsd:element ref="ns4:MediaServiceOCR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1f0932-4085-4466-8da9-dc765d33f25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545e34-2c25-43b6-826b-2da9a1a25bb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4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5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6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FF1BA5D-66CB-48CD-90DD-A506863890F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660F00A-6E1E-466A-9DE5-38E1F0189C8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d1f0932-4085-4466-8da9-dc765d33f258"/>
    <ds:schemaRef ds:uri="80545e34-2c25-43b6-826b-2da9a1a25bb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475CF12-6476-4444-828A-42F46E2677DE}">
  <ds:schemaRefs>
    <ds:schemaRef ds:uri="http://schemas.microsoft.com/office/2006/documentManagement/types"/>
    <ds:schemaRef ds:uri="http://purl.org/dc/elements/1.1/"/>
    <ds:schemaRef ds:uri="7d1f0932-4085-4466-8da9-dc765d33f258"/>
    <ds:schemaRef ds:uri="http://www.w3.org/XML/1998/namespace"/>
    <ds:schemaRef ds:uri="http://purl.org/dc/terms/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80545e34-2c25-43b6-826b-2da9a1a25bb5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1</TotalTime>
  <Words>1423</Words>
  <Application>Microsoft Office PowerPoint</Application>
  <PresentationFormat>Widescreen</PresentationFormat>
  <Paragraphs>915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Supplementary Figure 1.  Patency following venous stenting for non-thrombotic iliac vein lesions   Key:  * events reported per limb </vt:lpstr>
      <vt:lpstr>Supplementary Figure 2.  Patency following venous stenting as part of treatment for acute DVT  Key:  * events reported per limb δ open thrombectomy carried out before stent α may include some patient duplicates  </vt:lpstr>
      <vt:lpstr>Supplementary Figure 3.  Patency following venous stenting placed above the inguinal ligament for treatment of post-thrombotic syndrome   Key:  * events reported per limb ρ chronic total occlusions only</vt:lpstr>
      <vt:lpstr>PowerPoint Presentation</vt:lpstr>
      <vt:lpstr>Supplementary Figure 4.  Patency following venous stenting across the inguinal ligament for treatment of post-thrombotic syndrome  Key:  * events reported per limb α may include some patient duplicates ρ chronic total occlusions only γ inclusion of 3 patients with dedicated venous stents ε femoral vein intervention with angioplasty +/- stent carried out λ only braided nitinol stents included from this manuscript # inclusion of patients with endophlebectomy +/- fistula 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imary patency rates</dc:title>
  <dc:creator>Mustafa Majeed</dc:creator>
  <cp:lastModifiedBy>Production User 28</cp:lastModifiedBy>
  <cp:revision>55</cp:revision>
  <dcterms:created xsi:type="dcterms:W3CDTF">2021-01-05T12:07:19Z</dcterms:created>
  <dcterms:modified xsi:type="dcterms:W3CDTF">2022-04-22T08:22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F90F2ECA569EC488FE1B6EF59247D8A</vt:lpwstr>
  </property>
</Properties>
</file>